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5192" r:id="rId4"/>
  </p:sldMasterIdLst>
  <p:notesMasterIdLst>
    <p:notesMasterId r:id="rId6"/>
  </p:notesMasterIdLst>
  <p:sldIdLst>
    <p:sldId id="500" r:id="rId5"/>
  </p:sldIdLst>
  <p:sldSz cx="10287000" cy="6858000" type="35mm"/>
  <p:notesSz cx="6807200" cy="9939338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Helvetica" pitchFamily="34" charset="0"/>
        <a:ea typeface="Osaka"/>
        <a:cs typeface="Osaka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2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>
          <p15:clr>
            <a:srgbClr val="A4A3A4"/>
          </p15:clr>
        </p15:guide>
        <p15:guide id="2" pos="2145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elle Belanger" initials="MB" lastIdx="6" clrIdx="0">
    <p:extLst>
      <p:ext uri="{19B8F6BF-5375-455C-9EA6-DF929625EA0E}">
        <p15:presenceInfo xmlns:p15="http://schemas.microsoft.com/office/powerpoint/2012/main" userId="49bebe63d9e0dcce" providerId="Windows Live"/>
      </p:ext>
    </p:extLst>
  </p:cmAuthor>
  <p:cmAuthor id="2" name="Chiba Hikari" initials="CH" lastIdx="3" clrIdx="1">
    <p:extLst>
      <p:ext uri="{19B8F6BF-5375-455C-9EA6-DF929625EA0E}">
        <p15:presenceInfo xmlns:p15="http://schemas.microsoft.com/office/powerpoint/2012/main" userId="071bcaa7ba159b5b" providerId="Windows Live"/>
      </p:ext>
    </p:extLst>
  </p:cmAuthor>
  <p:cmAuthor id="3" name="Samejima Nobutaka(鮫島　信隆)" initials="SN" lastIdx="4" clrIdx="2">
    <p:extLst>
      <p:ext uri="{19B8F6BF-5375-455C-9EA6-DF929625EA0E}">
        <p15:presenceInfo xmlns:p15="http://schemas.microsoft.com/office/powerpoint/2012/main" userId="S-1-5-21-3841407579-178316750-4048479971-98739" providerId="AD"/>
      </p:ext>
    </p:extLst>
  </p:cmAuthor>
  <p:cmAuthor id="4" name="Araki Hidetaka(荒木　英隆)" initials="AH" lastIdx="15" clrIdx="3">
    <p:extLst>
      <p:ext uri="{19B8F6BF-5375-455C-9EA6-DF929625EA0E}">
        <p15:presenceInfo xmlns:p15="http://schemas.microsoft.com/office/powerpoint/2012/main" userId="S-1-5-21-3841407579-178316750-4048479971-98508" providerId="AD"/>
      </p:ext>
    </p:extLst>
  </p:cmAuthor>
  <p:cmAuthor id="5" name="Medical Writer" initials="MW" lastIdx="1" clrIdx="4">
    <p:extLst>
      <p:ext uri="{19B8F6BF-5375-455C-9EA6-DF929625EA0E}">
        <p15:presenceInfo xmlns:p15="http://schemas.microsoft.com/office/powerpoint/2012/main" userId="Medical Writ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FF"/>
    <a:srgbClr val="31859C"/>
    <a:srgbClr val="663300"/>
    <a:srgbClr val="CCCCFF"/>
    <a:srgbClr val="FF6600"/>
    <a:srgbClr val="0000FF"/>
    <a:srgbClr val="996633"/>
    <a:srgbClr val="FFFF99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505E3EF-67EA-436B-97B2-0124C06EBD24}" styleName="中間スタイル 4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8A107856-5554-42FB-B03E-39F5DBC370BA}" styleName="中間スタイル 4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88" autoAdjust="0"/>
    <p:restoredTop sz="92049" autoAdjust="0"/>
  </p:normalViewPr>
  <p:slideViewPr>
    <p:cSldViewPr snapToGrid="0">
      <p:cViewPr varScale="1">
        <p:scale>
          <a:sx n="105" d="100"/>
          <a:sy n="105" d="100"/>
        </p:scale>
        <p:origin x="1686" y="96"/>
      </p:cViewPr>
      <p:guideLst>
        <p:guide orient="horz" pos="2160"/>
        <p:guide pos="3240"/>
      </p:guideLst>
    </p:cSldViewPr>
  </p:slideViewPr>
  <p:outlineViewPr>
    <p:cViewPr>
      <p:scale>
        <a:sx n="33" d="100"/>
        <a:sy n="33" d="100"/>
      </p:scale>
      <p:origin x="0" y="370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-7134"/>
    </p:cViewPr>
  </p:sorterViewPr>
  <p:notesViewPr>
    <p:cSldViewPr snapToGrid="0">
      <p:cViewPr varScale="1">
        <p:scale>
          <a:sx n="56" d="100"/>
          <a:sy n="56" d="100"/>
        </p:scale>
        <p:origin x="-1288" y="-112"/>
      </p:cViewPr>
      <p:guideLst>
        <p:guide orient="horz" pos="3131"/>
        <p:guide pos="2145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62" tIns="46081" rIns="92162" bIns="46081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Times" charset="0"/>
                <a:ea typeface="Osaka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355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7625" y="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62" tIns="46081" rIns="92162" bIns="46081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" charset="0"/>
                <a:ea typeface="Osaka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6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606425" y="744538"/>
            <a:ext cx="5594350" cy="37290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355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06463" y="4721225"/>
            <a:ext cx="4994275" cy="4473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62" tIns="46081" rIns="92162" bIns="4608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2355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4245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62" tIns="46081" rIns="92162" bIns="46081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Times" charset="0"/>
                <a:ea typeface="Osaka" charset="-128"/>
                <a:cs typeface="+mn-cs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355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7625" y="9442450"/>
            <a:ext cx="2949575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162" tIns="46081" rIns="92162" bIns="46081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Times" pitchFamily="8" charset="0"/>
              </a:defRPr>
            </a:lvl1pPr>
          </a:lstStyle>
          <a:p>
            <a:pPr>
              <a:defRPr/>
            </a:pPr>
            <a:fld id="{982D7DC3-1FD1-411C-9B64-31E3AD2DF8A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636302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Osaka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Osaka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Osaka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Osaka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" charset="0"/>
        <a:ea typeface="Osaka" charset="-128"/>
        <a:cs typeface="Osaka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43936F65-5AF0-442B-AAB7-48B1E28E6421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D5AA16A3-1D16-4A94-B479-09C2D57D4CD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23338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D1FAD9F1-739A-4B56-9FDB-54F56E36B5A2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C1057C36-6F05-4519-8B9F-7FC2E35218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72616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EAF1C284-280B-4578-83A5-B26C09017A9D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3D74CC20-C0E9-4BBA-8394-5C440037538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3589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30DC1C4D-7FD0-4B14-B942-792E42901904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E44F90D2-5BFC-430A-81FF-5E913C8E91F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06257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044E7239-EFF7-405C-8C26-E8AD8A395328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12B9C810-96B9-45F5-9CF8-A6EFBB83D6B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5881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7793299D-5DA8-4486-9C35-F04C6C2F1215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3014676A-F4E8-4E9B-A361-D3B6A3F2B6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2114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BEAB5A79-7D8F-415D-B157-AF1E4870A22C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E7BDF22F-22FD-4C72-9F97-03A120A9A25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85535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6F7A7330-B8DA-4DB4-A449-9E4BFC2B24D3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790763C4-3ABB-4CEC-8050-87B38E24E8F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0273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4A14D83A-6DDD-4443-B057-3C16EBBA2F24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1CCEE3BF-60A2-40F3-A2FC-00C5B788709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6410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DA65FA91-4B5C-4C7F-9EAD-278DF4E8EB7C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21B16DF1-4FBB-46B6-BF3C-931E0B2509E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1260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46842764-B18F-4625-850B-B097DC0A3CA4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Helvetica"/>
                <a:ea typeface="Osaka"/>
                <a:cs typeface="Osaka"/>
              </a:defRPr>
            </a:lvl1pPr>
          </a:lstStyle>
          <a:p>
            <a:pPr>
              <a:defRPr/>
            </a:pPr>
            <a:fld id="{B5F610BC-7D3A-4997-9A59-6BD560998F5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0798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514350" y="274638"/>
            <a:ext cx="92583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514350" y="1600200"/>
            <a:ext cx="92583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0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Calibri"/>
                <a:ea typeface="ＭＳ Ｐゴシック"/>
                <a:cs typeface="+mn-cs"/>
              </a:defRPr>
            </a:lvl1pPr>
          </a:lstStyle>
          <a:p>
            <a:pPr>
              <a:defRPr/>
            </a:pPr>
            <a:fld id="{15B7C2E9-C1F5-4E19-8D7E-220DF6BC5089}" type="datetimeFigureOut">
              <a:rPr lang="ja-JP" altLang="en-US"/>
              <a:pPr>
                <a:defRPr/>
              </a:pPr>
              <a:t>2020/9/25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0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Calibri"/>
                <a:ea typeface="ＭＳ Ｐゴシック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0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Calibri"/>
                <a:ea typeface="ＭＳ Ｐゴシック"/>
                <a:cs typeface="+mn-cs"/>
              </a:defRPr>
            </a:lvl1pPr>
          </a:lstStyle>
          <a:p>
            <a:pPr>
              <a:defRPr/>
            </a:pPr>
            <a:fld id="{9177CFC1-9131-4305-90AF-96E029371E9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588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193" r:id="rId1"/>
    <p:sldLayoutId id="2147485194" r:id="rId2"/>
    <p:sldLayoutId id="2147485195" r:id="rId3"/>
    <p:sldLayoutId id="2147485196" r:id="rId4"/>
    <p:sldLayoutId id="2147485197" r:id="rId5"/>
    <p:sldLayoutId id="2147485198" r:id="rId6"/>
    <p:sldLayoutId id="2147485199" r:id="rId7"/>
    <p:sldLayoutId id="2147485200" r:id="rId8"/>
    <p:sldLayoutId id="2147485201" r:id="rId9"/>
    <p:sldLayoutId id="2147485202" r:id="rId10"/>
    <p:sldLayoutId id="214748520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テキスト ボックス 2"/>
          <p:cNvSpPr txBox="1">
            <a:spLocks noChangeArrowheads="1"/>
          </p:cNvSpPr>
          <p:nvPr/>
        </p:nvSpPr>
        <p:spPr bwMode="auto">
          <a:xfrm>
            <a:off x="5166590" y="5019550"/>
            <a:ext cx="107632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Month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39" name="テキスト ボックス 4"/>
          <p:cNvSpPr txBox="1">
            <a:spLocks noChangeArrowheads="1"/>
          </p:cNvSpPr>
          <p:nvPr/>
        </p:nvSpPr>
        <p:spPr bwMode="auto">
          <a:xfrm rot="-5400000">
            <a:off x="-753991" y="2767115"/>
            <a:ext cx="361950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OS in patients aged </a:t>
            </a:r>
            <a:r>
              <a:rPr lang="en-US" altLang="zh-TW" sz="1400" dirty="0"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≥75 years</a:t>
            </a:r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 </a:t>
            </a:r>
            <a:endParaRPr lang="ja-JP" altLang="en-US" sz="14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4" name="フリーフォーム 3"/>
          <p:cNvSpPr/>
          <p:nvPr/>
        </p:nvSpPr>
        <p:spPr>
          <a:xfrm>
            <a:off x="1686790" y="1065088"/>
            <a:ext cx="8329612" cy="3619500"/>
          </a:xfrm>
          <a:custGeom>
            <a:avLst/>
            <a:gdLst>
              <a:gd name="connsiteX0" fmla="*/ 0 w 7404100"/>
              <a:gd name="connsiteY0" fmla="*/ 0 h 3600450"/>
              <a:gd name="connsiteX1" fmla="*/ 0 w 7404100"/>
              <a:gd name="connsiteY1" fmla="*/ 3600450 h 3600450"/>
              <a:gd name="connsiteX2" fmla="*/ 7404100 w 7404100"/>
              <a:gd name="connsiteY2" fmla="*/ 3600450 h 3600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7404100" h="3600450">
                <a:moveTo>
                  <a:pt x="0" y="0"/>
                </a:moveTo>
                <a:lnTo>
                  <a:pt x="0" y="3600450"/>
                </a:lnTo>
                <a:lnTo>
                  <a:pt x="7404100" y="3600450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sz="1400">
              <a:solidFill>
                <a:prstClr val="white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341" name="グループ化 93"/>
          <p:cNvGrpSpPr>
            <a:grpSpLocks/>
          </p:cNvGrpSpPr>
          <p:nvPr/>
        </p:nvGrpSpPr>
        <p:grpSpPr bwMode="auto">
          <a:xfrm>
            <a:off x="1172440" y="1312738"/>
            <a:ext cx="442912" cy="3409346"/>
            <a:chOff x="590550" y="1771650"/>
            <a:chExt cx="393700" cy="3409504"/>
          </a:xfrm>
        </p:grpSpPr>
        <p:sp>
          <p:nvSpPr>
            <p:cNvPr id="14437" name="テキスト ボックス 5"/>
            <p:cNvSpPr txBox="1">
              <a:spLocks noChangeArrowheads="1"/>
            </p:cNvSpPr>
            <p:nvPr/>
          </p:nvSpPr>
          <p:spPr bwMode="auto">
            <a:xfrm>
              <a:off x="590550" y="177165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1.0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438" name="テキスト ボックス 95"/>
            <p:cNvSpPr txBox="1">
              <a:spLocks noChangeArrowheads="1"/>
            </p:cNvSpPr>
            <p:nvPr/>
          </p:nvSpPr>
          <p:spPr bwMode="auto">
            <a:xfrm>
              <a:off x="590550" y="240665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0.8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439" name="テキスト ボックス 96"/>
            <p:cNvSpPr txBox="1">
              <a:spLocks noChangeArrowheads="1"/>
            </p:cNvSpPr>
            <p:nvPr/>
          </p:nvSpPr>
          <p:spPr bwMode="auto">
            <a:xfrm>
              <a:off x="590550" y="303530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0.6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440" name="テキスト ボックス 97"/>
            <p:cNvSpPr txBox="1">
              <a:spLocks noChangeArrowheads="1"/>
            </p:cNvSpPr>
            <p:nvPr/>
          </p:nvSpPr>
          <p:spPr bwMode="auto">
            <a:xfrm>
              <a:off x="590550" y="367665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0.4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441" name="テキスト ボックス 98"/>
            <p:cNvSpPr txBox="1">
              <a:spLocks noChangeArrowheads="1"/>
            </p:cNvSpPr>
            <p:nvPr/>
          </p:nvSpPr>
          <p:spPr bwMode="auto">
            <a:xfrm>
              <a:off x="590550" y="431165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0.2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4442" name="テキスト ボックス 99"/>
            <p:cNvSpPr txBox="1">
              <a:spLocks noChangeArrowheads="1"/>
            </p:cNvSpPr>
            <p:nvPr/>
          </p:nvSpPr>
          <p:spPr bwMode="auto">
            <a:xfrm>
              <a:off x="590550" y="4965700"/>
              <a:ext cx="393700" cy="215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r" eaLnBrk="1" hangingPunct="1"/>
              <a:r>
                <a:rPr lang="en-US" altLang="ja-JP" sz="1400">
                  <a:solidFill>
                    <a:srgbClr val="000000"/>
                  </a:solidFill>
                  <a:latin typeface="Arial" panose="020B0604020202020204" pitchFamily="34" charset="0"/>
                  <a:ea typeface="Meiryo UI" pitchFamily="50" charset="-128"/>
                  <a:cs typeface="Arial" panose="020B0604020202020204" pitchFamily="34" charset="0"/>
                </a:rPr>
                <a:t>0.0</a:t>
              </a:r>
              <a:endParaRPr lang="ja-JP" altLang="en-US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4342" name="テキスト ボックス 101"/>
          <p:cNvSpPr txBox="1">
            <a:spLocks noChangeArrowheads="1"/>
          </p:cNvSpPr>
          <p:nvPr/>
        </p:nvSpPr>
        <p:spPr bwMode="auto">
          <a:xfrm>
            <a:off x="2259877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3" name="テキスト ボックス 102"/>
          <p:cNvSpPr txBox="1">
            <a:spLocks noChangeArrowheads="1"/>
          </p:cNvSpPr>
          <p:nvPr/>
        </p:nvSpPr>
        <p:spPr bwMode="auto">
          <a:xfrm>
            <a:off x="1537565" y="4748088"/>
            <a:ext cx="328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0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4" name="テキスト ボックス 103"/>
          <p:cNvSpPr txBox="1">
            <a:spLocks noChangeArrowheads="1"/>
          </p:cNvSpPr>
          <p:nvPr/>
        </p:nvSpPr>
        <p:spPr bwMode="auto">
          <a:xfrm>
            <a:off x="3707677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8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5" name="テキスト ボックス 104"/>
          <p:cNvSpPr txBox="1">
            <a:spLocks noChangeArrowheads="1"/>
          </p:cNvSpPr>
          <p:nvPr/>
        </p:nvSpPr>
        <p:spPr bwMode="auto">
          <a:xfrm>
            <a:off x="2983777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2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6" name="テキスト ボックス 105"/>
          <p:cNvSpPr txBox="1">
            <a:spLocks noChangeArrowheads="1"/>
          </p:cNvSpPr>
          <p:nvPr/>
        </p:nvSpPr>
        <p:spPr bwMode="auto">
          <a:xfrm>
            <a:off x="4429990" y="4748088"/>
            <a:ext cx="328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4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7" name="テキスト ボックス 106"/>
          <p:cNvSpPr txBox="1">
            <a:spLocks noChangeArrowheads="1"/>
          </p:cNvSpPr>
          <p:nvPr/>
        </p:nvSpPr>
        <p:spPr bwMode="auto">
          <a:xfrm>
            <a:off x="5877790" y="4748088"/>
            <a:ext cx="328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6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8" name="テキスト ボックス 107"/>
          <p:cNvSpPr txBox="1">
            <a:spLocks noChangeArrowheads="1"/>
          </p:cNvSpPr>
          <p:nvPr/>
        </p:nvSpPr>
        <p:spPr bwMode="auto">
          <a:xfrm>
            <a:off x="5153890" y="4748088"/>
            <a:ext cx="328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0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49" name="テキスト ボックス 108"/>
          <p:cNvSpPr txBox="1">
            <a:spLocks noChangeArrowheads="1"/>
          </p:cNvSpPr>
          <p:nvPr/>
        </p:nvSpPr>
        <p:spPr bwMode="auto">
          <a:xfrm>
            <a:off x="6601690" y="4748088"/>
            <a:ext cx="328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42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0" name="テキスト ボックス 109"/>
          <p:cNvSpPr txBox="1">
            <a:spLocks noChangeArrowheads="1"/>
          </p:cNvSpPr>
          <p:nvPr/>
        </p:nvSpPr>
        <p:spPr bwMode="auto">
          <a:xfrm>
            <a:off x="8047902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4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1" name="テキスト ボックス 110"/>
          <p:cNvSpPr txBox="1">
            <a:spLocks noChangeArrowheads="1"/>
          </p:cNvSpPr>
          <p:nvPr/>
        </p:nvSpPr>
        <p:spPr bwMode="auto">
          <a:xfrm>
            <a:off x="7324002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48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2" name="テキスト ボックス 111"/>
          <p:cNvSpPr txBox="1">
            <a:spLocks noChangeArrowheads="1"/>
          </p:cNvSpPr>
          <p:nvPr/>
        </p:nvSpPr>
        <p:spPr bwMode="auto">
          <a:xfrm>
            <a:off x="9495702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6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3" name="テキスト ボックス 112"/>
          <p:cNvSpPr txBox="1">
            <a:spLocks noChangeArrowheads="1"/>
          </p:cNvSpPr>
          <p:nvPr/>
        </p:nvSpPr>
        <p:spPr bwMode="auto">
          <a:xfrm>
            <a:off x="8771802" y="4748088"/>
            <a:ext cx="32861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0</a:t>
            </a:r>
            <a:endParaRPr lang="ja-JP" altLang="en-US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4" name="テキスト ボックス 198"/>
          <p:cNvSpPr txBox="1">
            <a:spLocks noChangeArrowheads="1"/>
          </p:cNvSpPr>
          <p:nvPr/>
        </p:nvSpPr>
        <p:spPr bwMode="auto">
          <a:xfrm>
            <a:off x="829540" y="5346575"/>
            <a:ext cx="359073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DTX</a:t>
            </a:r>
          </a:p>
          <a:p>
            <a:pPr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-1</a:t>
            </a:r>
            <a:endParaRPr lang="ja-JP" altLang="en-US" sz="14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55" name="テキスト ボックス 212"/>
          <p:cNvSpPr txBox="1">
            <a:spLocks noChangeArrowheads="1"/>
          </p:cNvSpPr>
          <p:nvPr/>
        </p:nvSpPr>
        <p:spPr bwMode="auto">
          <a:xfrm>
            <a:off x="2174152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4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14356" name="テキスト ボックス 213"/>
          <p:cNvSpPr txBox="1">
            <a:spLocks noChangeArrowheads="1"/>
          </p:cNvSpPr>
          <p:nvPr/>
        </p:nvSpPr>
        <p:spPr bwMode="auto">
          <a:xfrm>
            <a:off x="1459777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2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14357" name="テキスト ボックス 214"/>
          <p:cNvSpPr txBox="1">
            <a:spLocks noChangeArrowheads="1"/>
          </p:cNvSpPr>
          <p:nvPr/>
        </p:nvSpPr>
        <p:spPr bwMode="auto">
          <a:xfrm>
            <a:off x="3617190" y="5359275"/>
            <a:ext cx="4714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8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4358" name="テキスト ボックス 215"/>
          <p:cNvSpPr txBox="1">
            <a:spLocks noChangeArrowheads="1"/>
          </p:cNvSpPr>
          <p:nvPr/>
        </p:nvSpPr>
        <p:spPr bwMode="auto">
          <a:xfrm>
            <a:off x="2896465" y="5359275"/>
            <a:ext cx="4699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1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14359" name="テキスト ボックス 216"/>
          <p:cNvSpPr txBox="1">
            <a:spLocks noChangeArrowheads="1"/>
          </p:cNvSpPr>
          <p:nvPr/>
        </p:nvSpPr>
        <p:spPr bwMode="auto">
          <a:xfrm>
            <a:off x="4345852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4360" name="テキスト ボックス 217"/>
          <p:cNvSpPr txBox="1">
            <a:spLocks noChangeArrowheads="1"/>
          </p:cNvSpPr>
          <p:nvPr/>
        </p:nvSpPr>
        <p:spPr bwMode="auto">
          <a:xfrm>
            <a:off x="5796827" y="5359275"/>
            <a:ext cx="4699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361" name="テキスト ボックス 218"/>
          <p:cNvSpPr txBox="1">
            <a:spLocks noChangeArrowheads="1"/>
          </p:cNvSpPr>
          <p:nvPr/>
        </p:nvSpPr>
        <p:spPr bwMode="auto">
          <a:xfrm>
            <a:off x="5096740" y="5359275"/>
            <a:ext cx="4714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3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362" name="テキスト ボックス 219"/>
          <p:cNvSpPr txBox="1">
            <a:spLocks noChangeArrowheads="1"/>
          </p:cNvSpPr>
          <p:nvPr/>
        </p:nvSpPr>
        <p:spPr bwMode="auto">
          <a:xfrm>
            <a:off x="6517552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363" name="テキスト ボックス 220"/>
          <p:cNvSpPr txBox="1">
            <a:spLocks noChangeArrowheads="1"/>
          </p:cNvSpPr>
          <p:nvPr/>
        </p:nvSpPr>
        <p:spPr bwMode="auto">
          <a:xfrm>
            <a:off x="7960590" y="5359275"/>
            <a:ext cx="4714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endParaRPr lang="en-US" altLang="ja-JP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364" name="テキスト ボックス 221"/>
          <p:cNvSpPr txBox="1">
            <a:spLocks noChangeArrowheads="1"/>
          </p:cNvSpPr>
          <p:nvPr/>
        </p:nvSpPr>
        <p:spPr bwMode="auto">
          <a:xfrm>
            <a:off x="7231927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365" name="テキスト ボックス 223"/>
          <p:cNvSpPr txBox="1">
            <a:spLocks noChangeArrowheads="1"/>
          </p:cNvSpPr>
          <p:nvPr/>
        </p:nvSpPr>
        <p:spPr bwMode="auto">
          <a:xfrm>
            <a:off x="8689252" y="5359275"/>
            <a:ext cx="4714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 eaLnBrk="1" hangingPunct="1"/>
            <a:endParaRPr lang="en-US" altLang="ja-JP" sz="140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  <a:p>
            <a:pPr algn="ctr" eaLnBrk="1" hangingPunct="1"/>
            <a:r>
              <a:rPr lang="en-US" altLang="ja-JP" sz="140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366" name="テキスト ボックス 45"/>
          <p:cNvSpPr txBox="1">
            <a:spLocks noChangeArrowheads="1"/>
          </p:cNvSpPr>
          <p:nvPr/>
        </p:nvSpPr>
        <p:spPr bwMode="auto">
          <a:xfrm>
            <a:off x="40933" y="6201915"/>
            <a:ext cx="102870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85725"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Whisker</a:t>
            </a:r>
            <a:r>
              <a:rPr lang="en-NZ" altLang="ja-JP" sz="12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 indicate c</a:t>
            </a:r>
            <a:r>
              <a:rPr lang="en-US" altLang="ja-JP" sz="1200" dirty="0" err="1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ensoring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.</a:t>
            </a:r>
          </a:p>
          <a:p>
            <a:pPr marL="85725" eaLnBrk="1" hangingPunct="1"/>
            <a:endParaRPr lang="en-US" altLang="ja-JP" sz="12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  <a:p>
            <a:pPr marL="85725" eaLnBrk="1" hangingPunct="1"/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CI, confidence interval; DTX, docetaxel; HR, hazard ratio; OS, overall survival.</a:t>
            </a:r>
            <a:endParaRPr lang="ja-JP" altLang="en-US" sz="12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14367" name="テキスト ボックス 65"/>
          <p:cNvSpPr txBox="1">
            <a:spLocks noChangeArrowheads="1"/>
          </p:cNvSpPr>
          <p:nvPr/>
        </p:nvSpPr>
        <p:spPr bwMode="auto">
          <a:xfrm>
            <a:off x="2296390" y="4167211"/>
            <a:ext cx="600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DTX</a:t>
            </a:r>
          </a:p>
        </p:txBody>
      </p:sp>
      <p:cxnSp>
        <p:nvCxnSpPr>
          <p:cNvPr id="205" name="直線コネクタ 204"/>
          <p:cNvCxnSpPr>
            <a:cxnSpLocks/>
          </p:cNvCxnSpPr>
          <p:nvPr/>
        </p:nvCxnSpPr>
        <p:spPr bwMode="auto">
          <a:xfrm>
            <a:off x="1866144" y="4491061"/>
            <a:ext cx="295275" cy="1500"/>
          </a:xfrm>
          <a:prstGeom prst="line">
            <a:avLst/>
          </a:prstGeom>
          <a:ln w="28575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69" name="テキスト ボックス 69"/>
          <p:cNvSpPr txBox="1">
            <a:spLocks noChangeArrowheads="1"/>
          </p:cNvSpPr>
          <p:nvPr/>
        </p:nvSpPr>
        <p:spPr bwMode="auto">
          <a:xfrm>
            <a:off x="2296390" y="4364061"/>
            <a:ext cx="600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S-1</a:t>
            </a:r>
            <a:endParaRPr lang="ja-JP" altLang="en-US" sz="14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cxnSp>
        <p:nvCxnSpPr>
          <p:cNvPr id="207" name="直線コネクタ 206"/>
          <p:cNvCxnSpPr>
            <a:cxnSpLocks/>
          </p:cNvCxnSpPr>
          <p:nvPr/>
        </p:nvCxnSpPr>
        <p:spPr bwMode="auto">
          <a:xfrm>
            <a:off x="1862969" y="4262461"/>
            <a:ext cx="298450" cy="0"/>
          </a:xfrm>
          <a:prstGeom prst="line">
            <a:avLst/>
          </a:prstGeom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446" name="Group 1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12994"/>
              </p:ext>
            </p:extLst>
          </p:nvPr>
        </p:nvGraphicFramePr>
        <p:xfrm>
          <a:off x="4796287" y="873866"/>
          <a:ext cx="5100207" cy="1933578"/>
        </p:xfrm>
        <a:graphic>
          <a:graphicData uri="http://schemas.openxmlformats.org/drawingml/2006/table">
            <a:tbl>
              <a:tblPr/>
              <a:tblGrid>
                <a:gridCol w="13543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1782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28037">
                  <a:extLst>
                    <a:ext uri="{9D8B030D-6E8A-4147-A177-3AD203B41FA5}">
                      <a16:colId xmlns:a16="http://schemas.microsoft.com/office/drawing/2014/main" val="1070873310"/>
                    </a:ext>
                  </a:extLst>
                </a:gridCol>
              </a:tblGrid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ja-JP" altLang="en-US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S-1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DTX</a:t>
                      </a:r>
                      <a:endParaRPr kumimoji="0" lang="en-US" altLang="ja-JP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No. of patients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22</a:t>
                      </a:r>
                      <a:endParaRPr kumimoji="0" lang="en-US" altLang="ja-JP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Events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ja-JP" alt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HR, 0.54 (95% CI, 0.28–1.02)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altLang="ja-JP" sz="14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Median survival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18.2 months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11.3 months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226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ja-JP" alt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eiryo UI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(95% CI, 8.87–27.07)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eiryo UI" pitchFamily="50" charset="-128"/>
                          <a:cs typeface="Arial" panose="020B0604020202020204" pitchFamily="34" charset="0"/>
                        </a:rPr>
                        <a:t>(95% CI, 4.27–19.84)</a:t>
                      </a:r>
                    </a:p>
                  </a:txBody>
                  <a:tcPr marL="9525" marR="9525" marT="9521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pSp>
        <p:nvGrpSpPr>
          <p:cNvPr id="14465" name="Group 129"/>
          <p:cNvGrpSpPr>
            <a:grpSpLocks/>
          </p:cNvGrpSpPr>
          <p:nvPr/>
        </p:nvGrpSpPr>
        <p:grpSpPr bwMode="auto">
          <a:xfrm>
            <a:off x="1686790" y="1438150"/>
            <a:ext cx="6111875" cy="3192463"/>
            <a:chOff x="1109" y="4793"/>
            <a:chExt cx="4262" cy="3142"/>
          </a:xfrm>
        </p:grpSpPr>
        <p:sp>
          <p:nvSpPr>
            <p:cNvPr id="14462" name="Freeform 126"/>
            <p:cNvSpPr>
              <a:spLocks/>
            </p:cNvSpPr>
            <p:nvPr/>
          </p:nvSpPr>
          <p:spPr bwMode="auto">
            <a:xfrm>
              <a:off x="1109" y="4793"/>
              <a:ext cx="4262" cy="314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61" y="0"/>
                </a:cxn>
                <a:cxn ang="0">
                  <a:pos x="161" y="144"/>
                </a:cxn>
                <a:cxn ang="0">
                  <a:pos x="208" y="144"/>
                </a:cxn>
                <a:cxn ang="0">
                  <a:pos x="208" y="286"/>
                </a:cxn>
                <a:cxn ang="0">
                  <a:pos x="215" y="286"/>
                </a:cxn>
                <a:cxn ang="0">
                  <a:pos x="215" y="428"/>
                </a:cxn>
                <a:cxn ang="0">
                  <a:pos x="270" y="428"/>
                </a:cxn>
                <a:cxn ang="0">
                  <a:pos x="270" y="572"/>
                </a:cxn>
                <a:cxn ang="0">
                  <a:pos x="286" y="572"/>
                </a:cxn>
                <a:cxn ang="0">
                  <a:pos x="286" y="714"/>
                </a:cxn>
                <a:cxn ang="0">
                  <a:pos x="362" y="714"/>
                </a:cxn>
                <a:cxn ang="0">
                  <a:pos x="362" y="858"/>
                </a:cxn>
                <a:cxn ang="0">
                  <a:pos x="466" y="858"/>
                </a:cxn>
                <a:cxn ang="0">
                  <a:pos x="466" y="999"/>
                </a:cxn>
                <a:cxn ang="0">
                  <a:pos x="473" y="999"/>
                </a:cxn>
                <a:cxn ang="0">
                  <a:pos x="473" y="1144"/>
                </a:cxn>
                <a:cxn ang="0">
                  <a:pos x="648" y="1144"/>
                </a:cxn>
                <a:cxn ang="0">
                  <a:pos x="648" y="1285"/>
                </a:cxn>
                <a:cxn ang="0">
                  <a:pos x="721" y="1285"/>
                </a:cxn>
                <a:cxn ang="0">
                  <a:pos x="721" y="1427"/>
                </a:cxn>
                <a:cxn ang="0">
                  <a:pos x="841" y="1427"/>
                </a:cxn>
                <a:cxn ang="0">
                  <a:pos x="841" y="1571"/>
                </a:cxn>
                <a:cxn ang="0">
                  <a:pos x="1061" y="1571"/>
                </a:cxn>
                <a:cxn ang="0">
                  <a:pos x="1061" y="1713"/>
                </a:cxn>
                <a:cxn ang="0">
                  <a:pos x="1377" y="1713"/>
                </a:cxn>
                <a:cxn ang="0">
                  <a:pos x="1377" y="1857"/>
                </a:cxn>
                <a:cxn ang="0">
                  <a:pos x="1507" y="1857"/>
                </a:cxn>
                <a:cxn ang="0">
                  <a:pos x="1507" y="1999"/>
                </a:cxn>
                <a:cxn ang="0">
                  <a:pos x="1562" y="1999"/>
                </a:cxn>
                <a:cxn ang="0">
                  <a:pos x="1562" y="2143"/>
                </a:cxn>
                <a:cxn ang="0">
                  <a:pos x="1673" y="2143"/>
                </a:cxn>
                <a:cxn ang="0">
                  <a:pos x="1673" y="2284"/>
                </a:cxn>
                <a:cxn ang="0">
                  <a:pos x="1796" y="2284"/>
                </a:cxn>
                <a:cxn ang="0">
                  <a:pos x="1796" y="2426"/>
                </a:cxn>
                <a:cxn ang="0">
                  <a:pos x="2074" y="2426"/>
                </a:cxn>
                <a:cxn ang="0">
                  <a:pos x="2074" y="2570"/>
                </a:cxn>
                <a:cxn ang="0">
                  <a:pos x="2618" y="2570"/>
                </a:cxn>
                <a:cxn ang="0">
                  <a:pos x="2618" y="2759"/>
                </a:cxn>
                <a:cxn ang="0">
                  <a:pos x="4262" y="2759"/>
                </a:cxn>
                <a:cxn ang="0">
                  <a:pos x="4262" y="3142"/>
                </a:cxn>
              </a:cxnLst>
              <a:rect l="0" t="0" r="r" b="b"/>
              <a:pathLst>
                <a:path w="4262" h="3142">
                  <a:moveTo>
                    <a:pt x="0" y="0"/>
                  </a:moveTo>
                  <a:lnTo>
                    <a:pt x="161" y="0"/>
                  </a:lnTo>
                  <a:lnTo>
                    <a:pt x="161" y="144"/>
                  </a:lnTo>
                  <a:lnTo>
                    <a:pt x="208" y="144"/>
                  </a:lnTo>
                  <a:lnTo>
                    <a:pt x="208" y="286"/>
                  </a:lnTo>
                  <a:lnTo>
                    <a:pt x="215" y="286"/>
                  </a:lnTo>
                  <a:lnTo>
                    <a:pt x="215" y="428"/>
                  </a:lnTo>
                  <a:lnTo>
                    <a:pt x="270" y="428"/>
                  </a:lnTo>
                  <a:lnTo>
                    <a:pt x="270" y="572"/>
                  </a:lnTo>
                  <a:lnTo>
                    <a:pt x="286" y="572"/>
                  </a:lnTo>
                  <a:lnTo>
                    <a:pt x="286" y="714"/>
                  </a:lnTo>
                  <a:lnTo>
                    <a:pt x="362" y="714"/>
                  </a:lnTo>
                  <a:lnTo>
                    <a:pt x="362" y="858"/>
                  </a:lnTo>
                  <a:lnTo>
                    <a:pt x="466" y="858"/>
                  </a:lnTo>
                  <a:lnTo>
                    <a:pt x="466" y="999"/>
                  </a:lnTo>
                  <a:lnTo>
                    <a:pt x="473" y="999"/>
                  </a:lnTo>
                  <a:lnTo>
                    <a:pt x="473" y="1144"/>
                  </a:lnTo>
                  <a:lnTo>
                    <a:pt x="648" y="1144"/>
                  </a:lnTo>
                  <a:lnTo>
                    <a:pt x="648" y="1285"/>
                  </a:lnTo>
                  <a:lnTo>
                    <a:pt x="721" y="1285"/>
                  </a:lnTo>
                  <a:lnTo>
                    <a:pt x="721" y="1427"/>
                  </a:lnTo>
                  <a:lnTo>
                    <a:pt x="841" y="1427"/>
                  </a:lnTo>
                  <a:lnTo>
                    <a:pt x="841" y="1571"/>
                  </a:lnTo>
                  <a:lnTo>
                    <a:pt x="1061" y="1571"/>
                  </a:lnTo>
                  <a:lnTo>
                    <a:pt x="1061" y="1713"/>
                  </a:lnTo>
                  <a:lnTo>
                    <a:pt x="1377" y="1713"/>
                  </a:lnTo>
                  <a:lnTo>
                    <a:pt x="1377" y="1857"/>
                  </a:lnTo>
                  <a:lnTo>
                    <a:pt x="1507" y="1857"/>
                  </a:lnTo>
                  <a:lnTo>
                    <a:pt x="1507" y="1999"/>
                  </a:lnTo>
                  <a:lnTo>
                    <a:pt x="1562" y="1999"/>
                  </a:lnTo>
                  <a:lnTo>
                    <a:pt x="1562" y="2143"/>
                  </a:lnTo>
                  <a:lnTo>
                    <a:pt x="1673" y="2143"/>
                  </a:lnTo>
                  <a:lnTo>
                    <a:pt x="1673" y="2284"/>
                  </a:lnTo>
                  <a:lnTo>
                    <a:pt x="1796" y="2284"/>
                  </a:lnTo>
                  <a:lnTo>
                    <a:pt x="1796" y="2426"/>
                  </a:lnTo>
                  <a:lnTo>
                    <a:pt x="2074" y="2426"/>
                  </a:lnTo>
                  <a:lnTo>
                    <a:pt x="2074" y="2570"/>
                  </a:lnTo>
                  <a:lnTo>
                    <a:pt x="2618" y="2570"/>
                  </a:lnTo>
                  <a:lnTo>
                    <a:pt x="2618" y="2759"/>
                  </a:lnTo>
                  <a:lnTo>
                    <a:pt x="4262" y="2759"/>
                  </a:lnTo>
                  <a:lnTo>
                    <a:pt x="4262" y="3142"/>
                  </a:lnTo>
                </a:path>
              </a:pathLst>
            </a:custGeom>
            <a:noFill/>
            <a:ln w="28575" cap="flat" cmpd="sng">
              <a:solidFill>
                <a:schemeClr val="accent5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63" name="Line 127"/>
            <p:cNvSpPr>
              <a:spLocks noChangeShapeType="1"/>
            </p:cNvSpPr>
            <p:nvPr/>
          </p:nvSpPr>
          <p:spPr bwMode="auto">
            <a:xfrm flipV="1">
              <a:off x="3460" y="7269"/>
              <a:ext cx="0" cy="94"/>
            </a:xfrm>
            <a:prstGeom prst="line">
              <a:avLst/>
            </a:prstGeom>
            <a:noFill/>
            <a:ln w="28575">
              <a:solidFill>
                <a:schemeClr val="accent5"/>
              </a:solidFill>
              <a:prstDash val="solid"/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64" name="Line 128"/>
            <p:cNvSpPr>
              <a:spLocks noChangeShapeType="1"/>
            </p:cNvSpPr>
            <p:nvPr/>
          </p:nvSpPr>
          <p:spPr bwMode="auto">
            <a:xfrm flipV="1">
              <a:off x="3972" y="7458"/>
              <a:ext cx="0" cy="94"/>
            </a:xfrm>
            <a:prstGeom prst="line">
              <a:avLst/>
            </a:prstGeom>
            <a:noFill/>
            <a:ln w="28575">
              <a:solidFill>
                <a:schemeClr val="accent5"/>
              </a:solidFill>
              <a:prstDash val="solid"/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459" name="Group 123"/>
          <p:cNvGrpSpPr>
            <a:grpSpLocks/>
          </p:cNvGrpSpPr>
          <p:nvPr/>
        </p:nvGrpSpPr>
        <p:grpSpPr bwMode="auto">
          <a:xfrm>
            <a:off x="1686790" y="1438150"/>
            <a:ext cx="7387457" cy="2811463"/>
            <a:chOff x="1109" y="4793"/>
            <a:chExt cx="5152" cy="2767"/>
          </a:xfrm>
        </p:grpSpPr>
        <p:sp>
          <p:nvSpPr>
            <p:cNvPr id="14451" name="Line 115"/>
            <p:cNvSpPr>
              <a:spLocks noChangeShapeType="1"/>
            </p:cNvSpPr>
            <p:nvPr/>
          </p:nvSpPr>
          <p:spPr bwMode="auto">
            <a:xfrm>
              <a:off x="3762" y="7231"/>
              <a:ext cx="0" cy="0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2" name="Freeform 116"/>
            <p:cNvSpPr>
              <a:spLocks/>
            </p:cNvSpPr>
            <p:nvPr/>
          </p:nvSpPr>
          <p:spPr bwMode="auto">
            <a:xfrm>
              <a:off x="1109" y="4793"/>
              <a:ext cx="5152" cy="2767"/>
            </a:xfrm>
            <a:custGeom>
              <a:avLst/>
              <a:gdLst>
                <a:gd name="connsiteX0" fmla="*/ 10010 w 10010"/>
                <a:gd name="connsiteY0" fmla="*/ 10000 h 10000"/>
                <a:gd name="connsiteX1" fmla="*/ 6553 w 10010"/>
                <a:gd name="connsiteY1" fmla="*/ 10000 h 10000"/>
                <a:gd name="connsiteX2" fmla="*/ 6553 w 10010"/>
                <a:gd name="connsiteY2" fmla="*/ 9317 h 10000"/>
                <a:gd name="connsiteX3" fmla="*/ 6361 w 10010"/>
                <a:gd name="connsiteY3" fmla="*/ 9317 h 10000"/>
                <a:gd name="connsiteX4" fmla="*/ 6361 w 10010"/>
                <a:gd name="connsiteY4" fmla="*/ 8811 h 10000"/>
                <a:gd name="connsiteX5" fmla="*/ 4686 w 10010"/>
                <a:gd name="connsiteY5" fmla="*/ 8811 h 10000"/>
                <a:gd name="connsiteX6" fmla="*/ 4686 w 10010"/>
                <a:gd name="connsiteY6" fmla="*/ 8446 h 10000"/>
                <a:gd name="connsiteX7" fmla="*/ 4554 w 10010"/>
                <a:gd name="connsiteY7" fmla="*/ 8446 h 10000"/>
                <a:gd name="connsiteX8" fmla="*/ 4554 w 10010"/>
                <a:gd name="connsiteY8" fmla="*/ 8070 h 10000"/>
                <a:gd name="connsiteX9" fmla="*/ 4539 w 10010"/>
                <a:gd name="connsiteY9" fmla="*/ 8070 h 10000"/>
                <a:gd name="connsiteX10" fmla="*/ 4539 w 10010"/>
                <a:gd name="connsiteY10" fmla="*/ 7720 h 10000"/>
                <a:gd name="connsiteX11" fmla="*/ 4434 w 10010"/>
                <a:gd name="connsiteY11" fmla="*/ 7720 h 10000"/>
                <a:gd name="connsiteX12" fmla="*/ 4434 w 10010"/>
                <a:gd name="connsiteY12" fmla="*/ 7351 h 10000"/>
                <a:gd name="connsiteX13" fmla="*/ 4002 w 10010"/>
                <a:gd name="connsiteY13" fmla="*/ 7351 h 10000"/>
                <a:gd name="connsiteX14" fmla="*/ 4002 w 10010"/>
                <a:gd name="connsiteY14" fmla="*/ 7018 h 10000"/>
                <a:gd name="connsiteX15" fmla="*/ 3952 w 10010"/>
                <a:gd name="connsiteY15" fmla="*/ 7018 h 10000"/>
                <a:gd name="connsiteX16" fmla="*/ 3952 w 10010"/>
                <a:gd name="connsiteY16" fmla="*/ 6686 h 10000"/>
                <a:gd name="connsiteX17" fmla="*/ 3668 w 10010"/>
                <a:gd name="connsiteY17" fmla="*/ 6686 h 10000"/>
                <a:gd name="connsiteX18" fmla="*/ 3668 w 10010"/>
                <a:gd name="connsiteY18" fmla="*/ 6346 h 10000"/>
                <a:gd name="connsiteX19" fmla="*/ 3635 w 10010"/>
                <a:gd name="connsiteY19" fmla="*/ 6346 h 10000"/>
                <a:gd name="connsiteX20" fmla="*/ 3635 w 10010"/>
                <a:gd name="connsiteY20" fmla="*/ 6014 h 10000"/>
                <a:gd name="connsiteX21" fmla="*/ 3534 w 10010"/>
                <a:gd name="connsiteY21" fmla="*/ 6014 h 10000"/>
                <a:gd name="connsiteX22" fmla="*/ 3534 w 10010"/>
                <a:gd name="connsiteY22" fmla="*/ 5678 h 10000"/>
                <a:gd name="connsiteX23" fmla="*/ 2409 w 10010"/>
                <a:gd name="connsiteY23" fmla="*/ 5678 h 10000"/>
                <a:gd name="connsiteX24" fmla="*/ 2409 w 10010"/>
                <a:gd name="connsiteY24" fmla="*/ 5345 h 10000"/>
                <a:gd name="connsiteX25" fmla="*/ 2328 w 10010"/>
                <a:gd name="connsiteY25" fmla="*/ 5345 h 10000"/>
                <a:gd name="connsiteX26" fmla="*/ 2328 w 10010"/>
                <a:gd name="connsiteY26" fmla="*/ 5013 h 10000"/>
                <a:gd name="connsiteX27" fmla="*/ 2092 w 10010"/>
                <a:gd name="connsiteY27" fmla="*/ 5013 h 10000"/>
                <a:gd name="connsiteX28" fmla="*/ 2092 w 10010"/>
                <a:gd name="connsiteY28" fmla="*/ 4673 h 10000"/>
                <a:gd name="connsiteX29" fmla="*/ 2061 w 10010"/>
                <a:gd name="connsiteY29" fmla="*/ 4673 h 10000"/>
                <a:gd name="connsiteX30" fmla="*/ 2061 w 10010"/>
                <a:gd name="connsiteY30" fmla="*/ 4340 h 10000"/>
                <a:gd name="connsiteX31" fmla="*/ 1890 w 10010"/>
                <a:gd name="connsiteY31" fmla="*/ 4340 h 10000"/>
                <a:gd name="connsiteX32" fmla="*/ 1890 w 10010"/>
                <a:gd name="connsiteY32" fmla="*/ 4004 h 10000"/>
                <a:gd name="connsiteX33" fmla="*/ 1539 w 10010"/>
                <a:gd name="connsiteY33" fmla="*/ 4004 h 10000"/>
                <a:gd name="connsiteX34" fmla="*/ 1539 w 10010"/>
                <a:gd name="connsiteY34" fmla="*/ 3672 h 10000"/>
                <a:gd name="connsiteX35" fmla="*/ 1455 w 10010"/>
                <a:gd name="connsiteY35" fmla="*/ 3672 h 10000"/>
                <a:gd name="connsiteX36" fmla="*/ 1455 w 10010"/>
                <a:gd name="connsiteY36" fmla="*/ 3347 h 10000"/>
                <a:gd name="connsiteX37" fmla="*/ 1111 w 10010"/>
                <a:gd name="connsiteY37" fmla="*/ 3347 h 10000"/>
                <a:gd name="connsiteX38" fmla="*/ 1111 w 10010"/>
                <a:gd name="connsiteY38" fmla="*/ 3000 h 10000"/>
                <a:gd name="connsiteX39" fmla="*/ 997 w 10010"/>
                <a:gd name="connsiteY39" fmla="*/ 3000 h 10000"/>
                <a:gd name="connsiteX40" fmla="*/ 997 w 10010"/>
                <a:gd name="connsiteY40" fmla="*/ 2664 h 10000"/>
                <a:gd name="connsiteX41" fmla="*/ 977 w 10010"/>
                <a:gd name="connsiteY41" fmla="*/ 2664 h 10000"/>
                <a:gd name="connsiteX42" fmla="*/ 977 w 10010"/>
                <a:gd name="connsiteY42" fmla="*/ 2342 h 10000"/>
                <a:gd name="connsiteX43" fmla="*/ 973 w 10010"/>
                <a:gd name="connsiteY43" fmla="*/ 2342 h 10000"/>
                <a:gd name="connsiteX44" fmla="*/ 973 w 10010"/>
                <a:gd name="connsiteY44" fmla="*/ 2009 h 10000"/>
                <a:gd name="connsiteX45" fmla="*/ 936 w 10010"/>
                <a:gd name="connsiteY45" fmla="*/ 2009 h 10000"/>
                <a:gd name="connsiteX46" fmla="*/ 936 w 10010"/>
                <a:gd name="connsiteY46" fmla="*/ 1673 h 10000"/>
                <a:gd name="connsiteX47" fmla="*/ 872 w 10010"/>
                <a:gd name="connsiteY47" fmla="*/ 1673 h 10000"/>
                <a:gd name="connsiteX48" fmla="*/ 872 w 10010"/>
                <a:gd name="connsiteY48" fmla="*/ 1334 h 10000"/>
                <a:gd name="connsiteX49" fmla="*/ 721 w 10010"/>
                <a:gd name="connsiteY49" fmla="*/ 1334 h 10000"/>
                <a:gd name="connsiteX50" fmla="*/ 721 w 10010"/>
                <a:gd name="connsiteY50" fmla="*/ 1001 h 10000"/>
                <a:gd name="connsiteX51" fmla="*/ 556 w 10010"/>
                <a:gd name="connsiteY51" fmla="*/ 1001 h 10000"/>
                <a:gd name="connsiteX52" fmla="*/ 556 w 10010"/>
                <a:gd name="connsiteY52" fmla="*/ 669 h 10000"/>
                <a:gd name="connsiteX53" fmla="*/ 289 w 10010"/>
                <a:gd name="connsiteY53" fmla="*/ 669 h 10000"/>
                <a:gd name="connsiteX54" fmla="*/ 289 w 10010"/>
                <a:gd name="connsiteY54" fmla="*/ 336 h 10000"/>
                <a:gd name="connsiteX55" fmla="*/ 124 w 10010"/>
                <a:gd name="connsiteY55" fmla="*/ 336 h 10000"/>
                <a:gd name="connsiteX56" fmla="*/ 124 w 10010"/>
                <a:gd name="connsiteY56" fmla="*/ 0 h 10000"/>
                <a:gd name="connsiteX57" fmla="*/ 0 w 10010"/>
                <a:gd name="connsiteY57" fmla="*/ 0 h 1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</a:cxnLst>
              <a:rect l="l" t="t" r="r" b="b"/>
              <a:pathLst>
                <a:path w="10010" h="10000">
                  <a:moveTo>
                    <a:pt x="10010" y="10000"/>
                  </a:moveTo>
                  <a:lnTo>
                    <a:pt x="6553" y="10000"/>
                  </a:lnTo>
                  <a:lnTo>
                    <a:pt x="6553" y="9317"/>
                  </a:lnTo>
                  <a:lnTo>
                    <a:pt x="6361" y="9317"/>
                  </a:lnTo>
                  <a:lnTo>
                    <a:pt x="6361" y="8811"/>
                  </a:lnTo>
                  <a:lnTo>
                    <a:pt x="4686" y="8811"/>
                  </a:lnTo>
                  <a:lnTo>
                    <a:pt x="4686" y="8446"/>
                  </a:lnTo>
                  <a:lnTo>
                    <a:pt x="4554" y="8446"/>
                  </a:lnTo>
                  <a:lnTo>
                    <a:pt x="4554" y="8070"/>
                  </a:lnTo>
                  <a:lnTo>
                    <a:pt x="4539" y="8070"/>
                  </a:lnTo>
                  <a:lnTo>
                    <a:pt x="4539" y="7720"/>
                  </a:lnTo>
                  <a:lnTo>
                    <a:pt x="4434" y="7720"/>
                  </a:lnTo>
                  <a:lnTo>
                    <a:pt x="4434" y="7351"/>
                  </a:lnTo>
                  <a:lnTo>
                    <a:pt x="4002" y="7351"/>
                  </a:lnTo>
                  <a:lnTo>
                    <a:pt x="4002" y="7018"/>
                  </a:lnTo>
                  <a:lnTo>
                    <a:pt x="3952" y="7018"/>
                  </a:lnTo>
                  <a:lnTo>
                    <a:pt x="3952" y="6686"/>
                  </a:lnTo>
                  <a:lnTo>
                    <a:pt x="3668" y="6686"/>
                  </a:lnTo>
                  <a:lnTo>
                    <a:pt x="3668" y="6346"/>
                  </a:lnTo>
                  <a:lnTo>
                    <a:pt x="3635" y="6346"/>
                  </a:lnTo>
                  <a:lnTo>
                    <a:pt x="3635" y="6014"/>
                  </a:lnTo>
                  <a:lnTo>
                    <a:pt x="3534" y="6014"/>
                  </a:lnTo>
                  <a:lnTo>
                    <a:pt x="3534" y="5678"/>
                  </a:lnTo>
                  <a:lnTo>
                    <a:pt x="2409" y="5678"/>
                  </a:lnTo>
                  <a:lnTo>
                    <a:pt x="2409" y="5345"/>
                  </a:lnTo>
                  <a:lnTo>
                    <a:pt x="2328" y="5345"/>
                  </a:lnTo>
                  <a:lnTo>
                    <a:pt x="2328" y="5013"/>
                  </a:lnTo>
                  <a:lnTo>
                    <a:pt x="2092" y="5013"/>
                  </a:lnTo>
                  <a:lnTo>
                    <a:pt x="2092" y="4673"/>
                  </a:lnTo>
                  <a:lnTo>
                    <a:pt x="2061" y="4673"/>
                  </a:lnTo>
                  <a:lnTo>
                    <a:pt x="2061" y="4340"/>
                  </a:lnTo>
                  <a:lnTo>
                    <a:pt x="1890" y="4340"/>
                  </a:lnTo>
                  <a:lnTo>
                    <a:pt x="1890" y="4004"/>
                  </a:lnTo>
                  <a:lnTo>
                    <a:pt x="1539" y="4004"/>
                  </a:lnTo>
                  <a:lnTo>
                    <a:pt x="1539" y="3672"/>
                  </a:lnTo>
                  <a:lnTo>
                    <a:pt x="1455" y="3672"/>
                  </a:lnTo>
                  <a:lnTo>
                    <a:pt x="1455" y="3347"/>
                  </a:lnTo>
                  <a:lnTo>
                    <a:pt x="1111" y="3347"/>
                  </a:lnTo>
                  <a:lnTo>
                    <a:pt x="1111" y="3000"/>
                  </a:lnTo>
                  <a:lnTo>
                    <a:pt x="997" y="3000"/>
                  </a:lnTo>
                  <a:lnTo>
                    <a:pt x="997" y="2664"/>
                  </a:lnTo>
                  <a:lnTo>
                    <a:pt x="977" y="2664"/>
                  </a:lnTo>
                  <a:lnTo>
                    <a:pt x="977" y="2342"/>
                  </a:lnTo>
                  <a:lnTo>
                    <a:pt x="973" y="2342"/>
                  </a:lnTo>
                  <a:lnTo>
                    <a:pt x="973" y="2009"/>
                  </a:lnTo>
                  <a:lnTo>
                    <a:pt x="936" y="2009"/>
                  </a:lnTo>
                  <a:lnTo>
                    <a:pt x="936" y="1673"/>
                  </a:lnTo>
                  <a:lnTo>
                    <a:pt x="872" y="1673"/>
                  </a:lnTo>
                  <a:lnTo>
                    <a:pt x="872" y="1334"/>
                  </a:lnTo>
                  <a:lnTo>
                    <a:pt x="721" y="1334"/>
                  </a:lnTo>
                  <a:lnTo>
                    <a:pt x="721" y="1001"/>
                  </a:lnTo>
                  <a:lnTo>
                    <a:pt x="556" y="1001"/>
                  </a:lnTo>
                  <a:lnTo>
                    <a:pt x="556" y="669"/>
                  </a:lnTo>
                  <a:lnTo>
                    <a:pt x="289" y="669"/>
                  </a:lnTo>
                  <a:lnTo>
                    <a:pt x="289" y="336"/>
                  </a:lnTo>
                  <a:lnTo>
                    <a:pt x="124" y="336"/>
                  </a:lnTo>
                  <a:lnTo>
                    <a:pt x="124" y="0"/>
                  </a:lnTo>
                  <a:lnTo>
                    <a:pt x="0" y="0"/>
                  </a:lnTo>
                </a:path>
              </a:pathLst>
            </a:custGeom>
            <a:noFill/>
            <a:ln w="28575" cap="flat" cmpd="sng">
              <a:solidFill>
                <a:schemeClr val="accent6"/>
              </a:solidFill>
              <a:prstDash val="solid"/>
              <a:miter lim="800000"/>
              <a:headEnd type="none" w="med" len="med"/>
              <a:tailEnd type="none" w="med" len="med"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3" name="Line 117"/>
            <p:cNvSpPr>
              <a:spLocks noChangeShapeType="1"/>
            </p:cNvSpPr>
            <p:nvPr/>
          </p:nvSpPr>
          <p:spPr bwMode="auto">
            <a:xfrm flipV="1">
              <a:off x="3254" y="6731"/>
              <a:ext cx="0" cy="96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4" name="Line 118"/>
            <p:cNvSpPr>
              <a:spLocks noChangeShapeType="1"/>
            </p:cNvSpPr>
            <p:nvPr/>
          </p:nvSpPr>
          <p:spPr bwMode="auto">
            <a:xfrm flipV="1">
              <a:off x="3575" y="7137"/>
              <a:ext cx="0" cy="94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5" name="Line 119"/>
            <p:cNvSpPr>
              <a:spLocks noChangeShapeType="1"/>
            </p:cNvSpPr>
            <p:nvPr/>
          </p:nvSpPr>
          <p:spPr bwMode="auto">
            <a:xfrm flipV="1">
              <a:off x="3762" y="7137"/>
              <a:ext cx="0" cy="94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6" name="Line 120"/>
            <p:cNvSpPr>
              <a:spLocks noChangeShapeType="1"/>
            </p:cNvSpPr>
            <p:nvPr/>
          </p:nvSpPr>
          <p:spPr bwMode="auto">
            <a:xfrm flipV="1">
              <a:off x="4414" y="7276"/>
              <a:ext cx="0" cy="95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7" name="Line 121"/>
            <p:cNvSpPr>
              <a:spLocks noChangeShapeType="1"/>
            </p:cNvSpPr>
            <p:nvPr/>
          </p:nvSpPr>
          <p:spPr bwMode="auto">
            <a:xfrm flipV="1">
              <a:off x="5449" y="7465"/>
              <a:ext cx="0" cy="95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58" name="Line 122"/>
            <p:cNvSpPr>
              <a:spLocks noChangeShapeType="1"/>
            </p:cNvSpPr>
            <p:nvPr/>
          </p:nvSpPr>
          <p:spPr bwMode="auto">
            <a:xfrm flipV="1">
              <a:off x="6252" y="7465"/>
              <a:ext cx="0" cy="95"/>
            </a:xfrm>
            <a:prstGeom prst="line">
              <a:avLst/>
            </a:prstGeom>
            <a:noFill/>
            <a:ln w="28575">
              <a:solidFill>
                <a:schemeClr val="accent6"/>
              </a:solidFill>
              <a:miter lim="800000"/>
              <a:headEnd/>
              <a:tailEnd/>
            </a:ln>
            <a:effectLst/>
          </p:spPr>
          <p:txBody>
            <a:bodyPr/>
            <a:lstStyle/>
            <a:p>
              <a:pPr eaLnBrk="1" hangingPunct="1"/>
              <a:endParaRPr lang="ja-JP" altLang="en-US" sz="14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" name="テキスト ボックス 2">
            <a:extLst>
              <a:ext uri="{FF2B5EF4-FFF2-40B4-BE49-F238E27FC236}">
                <a16:creationId xmlns:a16="http://schemas.microsoft.com/office/drawing/2014/main" id="{3CB3016C-300F-4799-9A0D-20CADBC614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638" y="5344164"/>
            <a:ext cx="805161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eaLnBrk="1" hangingPunct="1"/>
            <a:r>
              <a:rPr lang="en-US" altLang="ja-JP" sz="1400" dirty="0">
                <a:solidFill>
                  <a:srgbClr val="000000"/>
                </a:solidFill>
                <a:latin typeface="Arial" panose="020B0604020202020204" pitchFamily="34" charset="0"/>
                <a:ea typeface="Meiryo UI" pitchFamily="50" charset="-128"/>
                <a:cs typeface="Arial" panose="020B0604020202020204" pitchFamily="34" charset="0"/>
              </a:rPr>
              <a:t>No. of patients</a:t>
            </a:r>
            <a:endParaRPr lang="ja-JP" altLang="en-US" sz="1400" dirty="0">
              <a:solidFill>
                <a:srgbClr val="000000"/>
              </a:solidFill>
              <a:latin typeface="Arial" panose="020B0604020202020204" pitchFamily="34" charset="0"/>
              <a:ea typeface="Meiryo UI" pitchFamily="50" charset="-128"/>
              <a:cs typeface="Arial" panose="020B0604020202020204" pitchFamily="34" charset="0"/>
            </a:endParaRPr>
          </a:p>
        </p:txBody>
      </p:sp>
      <p:sp>
        <p:nvSpPr>
          <p:cNvPr id="60" name="Text Box 29">
            <a:extLst>
              <a:ext uri="{FF2B5EF4-FFF2-40B4-BE49-F238E27FC236}">
                <a16:creationId xmlns:a16="http://schemas.microsoft.com/office/drawing/2014/main" id="{404A5130-6833-411E-88B0-99DC154CFD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904" y="199304"/>
            <a:ext cx="10051058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1pPr>
            <a:lvl2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</a:defRPr>
            </a:lvl9pPr>
          </a:lstStyle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600" dirty="0">
                <a:ea typeface="メイリオ" panose="020B0604030504040204" pitchFamily="50" charset="-128"/>
                <a:cs typeface="Arial" panose="020B0604020202020204" pitchFamily="34" charset="0"/>
              </a:rPr>
              <a:t>Supplemental Data 1. Kaplan–Meier graphical representations of overall survival in patients aged ≥75 years</a:t>
            </a:r>
          </a:p>
        </p:txBody>
      </p:sp>
    </p:spTree>
    <p:extLst>
      <p:ext uri="{BB962C8B-B14F-4D97-AF65-F5344CB8AC3E}">
        <p14:creationId xmlns:p14="http://schemas.microsoft.com/office/powerpoint/2010/main" val="1777184712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294634D9D3C5624681AE9374D8C4F84E" ma:contentTypeVersion="4" ma:contentTypeDescription="新しいドキュメントを作成します。" ma:contentTypeScope="" ma:versionID="ff64051816ddbc44d5c289aa739feab1">
  <xsd:schema xmlns:xsd="http://www.w3.org/2001/XMLSchema" xmlns:xs="http://www.w3.org/2001/XMLSchema" xmlns:p="http://schemas.microsoft.com/office/2006/metadata/properties" xmlns:ns2="f24b21be-fbee-4620-95dc-e674cfd937ef" targetNamespace="http://schemas.microsoft.com/office/2006/metadata/properties" ma:root="true" ma:fieldsID="ff21504b143988a351bb48391cdae45f" ns2:_="">
    <xsd:import namespace="f24b21be-fbee-4620-95dc-e674cfd937e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4b21be-fbee-4620-95dc-e674cfd937e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98BF6A1-B2A0-4373-B4B9-581A407C30C1}">
  <ds:schemaRefs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schemas.openxmlformats.org/package/2006/metadata/core-properties"/>
    <ds:schemaRef ds:uri="http://purl.org/dc/dcmitype/"/>
    <ds:schemaRef ds:uri="f24b21be-fbee-4620-95dc-e674cfd937ef"/>
    <ds:schemaRef ds:uri="http://schemas.microsoft.com/office/infopath/2007/PartnerControls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6F8EF6AA-3479-437C-8304-EE8BFE8B049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24b21be-fbee-4620-95dc-e674cfd937e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951EA50-1B30-4D7A-9215-3A01D336458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Don't touch:Microsoft Office 98:Templates:新しいプレゼンテーション</Template>
  <TotalTime>9446</TotalTime>
  <Words>138</Words>
  <Application>Microsoft Office PowerPoint</Application>
  <PresentationFormat>35mm スライド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</vt:lpstr>
      <vt:lpstr>1_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AST-LC試験 -70歳以上におけるサブグループ解析-</dc:title>
  <dc:creator>高橋利明</dc:creator>
  <cp:lastModifiedBy>Hikari Wilson</cp:lastModifiedBy>
  <cp:revision>120</cp:revision>
  <cp:lastPrinted>2017-09-13T06:27:31Z</cp:lastPrinted>
  <dcterms:created xsi:type="dcterms:W3CDTF">1999-02-18T08:49:32Z</dcterms:created>
  <dcterms:modified xsi:type="dcterms:W3CDTF">2020-09-25T03:14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94634D9D3C5624681AE9374D8C4F84E</vt:lpwstr>
  </property>
</Properties>
</file>